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554D7-9B04-4A00-91EB-FE4FD8BA106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B901C-4A8E-4735-A6CA-5224C42D02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5DAB8-9048-4CDF-A59F-BAA6136C64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8CB25-5FAE-4DE4-A936-407FF24507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4D6F9-1CA2-4C2F-81EC-8CA7D236EF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D62E5-49AB-4D73-8616-E4EC0AA964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CC5BA-ACAF-4CA4-B080-D861DF26CD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6912C-92D4-42F4-A12B-1FD95B553B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6331A-394B-4D67-B6B5-34C630C8C8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E42FD-4715-4FBF-AA71-11FAB3C68F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B724C-5C4C-48A2-A810-13CD7CED24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313C8-43EB-40B3-87FE-2139F976FF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40771E-736D-4C6F-8DF0-9A3F7E250D3A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52" descr=""/>
          <p:cNvPicPr/>
          <p:nvPr/>
        </p:nvPicPr>
        <p:blipFill>
          <a:blip r:embed="rId1"/>
          <a:stretch/>
        </p:blipFill>
        <p:spPr>
          <a:xfrm>
            <a:off x="4548240" y="1663560"/>
            <a:ext cx="2144520" cy="3232440"/>
          </a:xfrm>
          <a:prstGeom prst="rect">
            <a:avLst/>
          </a:prstGeom>
          <a:ln w="0">
            <a:noFill/>
          </a:ln>
        </p:spPr>
      </p:pic>
      <p:pic>
        <p:nvPicPr>
          <p:cNvPr id="42" name="Chart 7" descr=""/>
          <p:cNvPicPr/>
          <p:nvPr/>
        </p:nvPicPr>
        <p:blipFill>
          <a:blip r:embed="rId2"/>
          <a:stretch/>
        </p:blipFill>
        <p:spPr>
          <a:xfrm>
            <a:off x="6480" y="1663560"/>
            <a:ext cx="2157120" cy="3206880"/>
          </a:xfrm>
          <a:prstGeom prst="rect">
            <a:avLst/>
          </a:prstGeom>
          <a:ln w="0">
            <a:noFill/>
          </a:ln>
        </p:spPr>
      </p:pic>
      <p:sp>
        <p:nvSpPr>
          <p:cNvPr id="43" name="TextBox 9"/>
          <p:cNvSpPr/>
          <p:nvPr/>
        </p:nvSpPr>
        <p:spPr>
          <a:xfrm>
            <a:off x="727560" y="1411200"/>
            <a:ext cx="579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  <a:ea typeface="Arial"/>
              </a:rPr>
              <a:t>p53-/- lymphomas                  p53Q/- lymphomas                          p53-/- lymphoma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8"/>
          <p:cNvSpPr/>
          <p:nvPr/>
        </p:nvSpPr>
        <p:spPr>
          <a:xfrm>
            <a:off x="1049040" y="1906560"/>
            <a:ext cx="817920" cy="59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Arial"/>
                <a:ea typeface="Arial"/>
              </a:rPr>
              <a:t>Ctrl (n=6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Arial"/>
                <a:ea typeface="Arial"/>
              </a:rPr>
              <a:t>Gan (n=6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30"/>
          <p:cNvSpPr/>
          <p:nvPr/>
        </p:nvSpPr>
        <p:spPr>
          <a:xfrm>
            <a:off x="5449320" y="1919160"/>
            <a:ext cx="1179000" cy="59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Arial"/>
                <a:ea typeface="Arial"/>
              </a:rPr>
              <a:t>CTX (n=5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Arial"/>
                <a:ea typeface="Arial"/>
              </a:rPr>
              <a:t>CTX+Gan (n=5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Straight Connector 38"/>
          <p:cNvSpPr/>
          <p:nvPr/>
        </p:nvSpPr>
        <p:spPr>
          <a:xfrm>
            <a:off x="895320" y="2087640"/>
            <a:ext cx="192240" cy="0"/>
          </a:xfrm>
          <a:prstGeom prst="line">
            <a:avLst/>
          </a:prstGeom>
          <a:ln w="1908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Straight Connector 40"/>
          <p:cNvSpPr/>
          <p:nvPr/>
        </p:nvSpPr>
        <p:spPr>
          <a:xfrm>
            <a:off x="892080" y="2346480"/>
            <a:ext cx="192240" cy="0"/>
          </a:xfrm>
          <a:prstGeom prst="line">
            <a:avLst/>
          </a:prstGeom>
          <a:ln w="1908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Straight Connector 43"/>
          <p:cNvSpPr/>
          <p:nvPr/>
        </p:nvSpPr>
        <p:spPr>
          <a:xfrm>
            <a:off x="5299200" y="2087640"/>
            <a:ext cx="191880" cy="0"/>
          </a:xfrm>
          <a:prstGeom prst="line">
            <a:avLst/>
          </a:prstGeom>
          <a:ln w="1908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44"/>
          <p:cNvSpPr/>
          <p:nvPr/>
        </p:nvSpPr>
        <p:spPr>
          <a:xfrm>
            <a:off x="5294160" y="2346480"/>
            <a:ext cx="19224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Group 48"/>
          <p:cNvGrpSpPr/>
          <p:nvPr/>
        </p:nvGrpSpPr>
        <p:grpSpPr>
          <a:xfrm>
            <a:off x="-15840" y="5380200"/>
            <a:ext cx="6873840" cy="3173400"/>
            <a:chOff x="-15840" y="5380200"/>
            <a:chExt cx="6873840" cy="3173400"/>
          </a:xfrm>
        </p:grpSpPr>
        <p:grpSp>
          <p:nvGrpSpPr>
            <p:cNvPr id="51" name="Group 11"/>
            <p:cNvGrpSpPr/>
            <p:nvPr/>
          </p:nvGrpSpPr>
          <p:grpSpPr>
            <a:xfrm>
              <a:off x="-15840" y="5380200"/>
              <a:ext cx="6873840" cy="3173400"/>
              <a:chOff x="-15840" y="5380200"/>
              <a:chExt cx="6873840" cy="3173400"/>
            </a:xfrm>
          </p:grpSpPr>
          <p:pic>
            <p:nvPicPr>
              <p:cNvPr id="52" name="Chart 4" descr=""/>
              <p:cNvPicPr/>
              <p:nvPr/>
            </p:nvPicPr>
            <p:blipFill>
              <a:blip r:embed="rId3"/>
              <a:stretch/>
            </p:blipFill>
            <p:spPr>
              <a:xfrm>
                <a:off x="-15840" y="5481000"/>
                <a:ext cx="6873840" cy="3072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TextBox 10"/>
              <p:cNvSpPr/>
              <p:nvPr/>
            </p:nvSpPr>
            <p:spPr>
              <a:xfrm>
                <a:off x="2796480" y="5380200"/>
                <a:ext cx="1471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595959"/>
                    </a:solidFill>
                    <a:latin typeface="Arial"/>
                    <a:ea typeface="Arial"/>
                  </a:rPr>
                  <a:t>p53Q/- lymphomas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4" name="TextBox 35"/>
            <p:cNvSpPr/>
            <p:nvPr/>
          </p:nvSpPr>
          <p:spPr>
            <a:xfrm>
              <a:off x="5045760" y="5708520"/>
              <a:ext cx="1179000" cy="59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595959"/>
                  </a:solidFill>
                  <a:latin typeface="Arial"/>
                  <a:ea typeface="Arial"/>
                </a:rPr>
                <a:t>CTX (n=6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595959"/>
                  </a:solidFill>
                  <a:latin typeface="Arial"/>
                  <a:ea typeface="Arial"/>
                </a:rPr>
                <a:t>CTX+Gan (n=6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45"/>
            <p:cNvSpPr/>
            <p:nvPr/>
          </p:nvSpPr>
          <p:spPr>
            <a:xfrm>
              <a:off x="4865040" y="5884200"/>
              <a:ext cx="192240" cy="0"/>
            </a:xfrm>
            <a:prstGeom prst="line">
              <a:avLst/>
            </a:prstGeom>
            <a:ln w="190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Straight Connector 46"/>
            <p:cNvSpPr/>
            <p:nvPr/>
          </p:nvSpPr>
          <p:spPr>
            <a:xfrm>
              <a:off x="4861080" y="6157080"/>
              <a:ext cx="1922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TextBox 49"/>
          <p:cNvSpPr/>
          <p:nvPr/>
        </p:nvSpPr>
        <p:spPr>
          <a:xfrm>
            <a:off x="207000" y="11736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50"/>
          <p:cNvSpPr/>
          <p:nvPr/>
        </p:nvSpPr>
        <p:spPr>
          <a:xfrm>
            <a:off x="184320" y="963720"/>
            <a:ext cx="4728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                              b                             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51"/>
          <p:cNvSpPr/>
          <p:nvPr/>
        </p:nvSpPr>
        <p:spPr>
          <a:xfrm>
            <a:off x="177480" y="511344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8"/>
          <p:cNvSpPr/>
          <p:nvPr/>
        </p:nvSpPr>
        <p:spPr>
          <a:xfrm>
            <a:off x="3773160" y="1933560"/>
            <a:ext cx="817920" cy="59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Arial"/>
                <a:ea typeface="Arial"/>
              </a:rPr>
              <a:t>Ctrl (n=5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Arial"/>
                <a:ea typeface="Arial"/>
              </a:rPr>
              <a:t>Gan (n=5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traight Connector 29"/>
          <p:cNvSpPr/>
          <p:nvPr/>
        </p:nvSpPr>
        <p:spPr>
          <a:xfrm>
            <a:off x="3618000" y="2114640"/>
            <a:ext cx="191880" cy="0"/>
          </a:xfrm>
          <a:prstGeom prst="line">
            <a:avLst/>
          </a:prstGeom>
          <a:ln w="1908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Straight Connector 31"/>
          <p:cNvSpPr/>
          <p:nvPr/>
        </p:nvSpPr>
        <p:spPr>
          <a:xfrm>
            <a:off x="3613320" y="2373480"/>
            <a:ext cx="191880" cy="0"/>
          </a:xfrm>
          <a:prstGeom prst="line">
            <a:avLst/>
          </a:prstGeom>
          <a:ln w="1908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Chart 32" descr=""/>
          <p:cNvPicPr/>
          <p:nvPr/>
        </p:nvPicPr>
        <p:blipFill>
          <a:blip r:embed="rId4"/>
          <a:stretch/>
        </p:blipFill>
        <p:spPr>
          <a:xfrm>
            <a:off x="2133720" y="1731960"/>
            <a:ext cx="2206440" cy="3200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8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31T18:06:36Z</dcterms:created>
  <dc:creator>Molllab</dc:creator>
  <dc:description/>
  <dc:language>en-US</dc:language>
  <cp:lastModifiedBy>KC.Lalitha</cp:lastModifiedBy>
  <cp:lastPrinted>2016-11-30T20:14:40Z</cp:lastPrinted>
  <dcterms:modified xsi:type="dcterms:W3CDTF">2017-03-15T11:36:27Z</dcterms:modified>
  <cp:revision>167</cp:revision>
  <dc:subject/>
  <dc:title>PowerPoint Presentation</dc:title>
</cp:coreProperties>
</file>